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3" d="100"/>
          <a:sy n="73" d="100"/>
        </p:scale>
        <p:origin x="145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D52A4-B94C-45EB-AC15-6681DD6A8B37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A0C7A-4796-45F4-AE93-39BF77319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3985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D52A4-B94C-45EB-AC15-6681DD6A8B37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A0C7A-4796-45F4-AE93-39BF77319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5559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D52A4-B94C-45EB-AC15-6681DD6A8B37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A0C7A-4796-45F4-AE93-39BF77319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3163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D52A4-B94C-45EB-AC15-6681DD6A8B37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A0C7A-4796-45F4-AE93-39BF77319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4017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D52A4-B94C-45EB-AC15-6681DD6A8B37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A0C7A-4796-45F4-AE93-39BF77319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8066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D52A4-B94C-45EB-AC15-6681DD6A8B37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A0C7A-4796-45F4-AE93-39BF77319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0022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D52A4-B94C-45EB-AC15-6681DD6A8B37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A0C7A-4796-45F4-AE93-39BF77319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22224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D52A4-B94C-45EB-AC15-6681DD6A8B37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A0C7A-4796-45F4-AE93-39BF77319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6686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D52A4-B94C-45EB-AC15-6681DD6A8B37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A0C7A-4796-45F4-AE93-39BF77319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7360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D52A4-B94C-45EB-AC15-6681DD6A8B37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A0C7A-4796-45F4-AE93-39BF77319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3415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D52A4-B94C-45EB-AC15-6681DD6A8B37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A0C7A-4796-45F4-AE93-39BF77319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9472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5D52A4-B94C-45EB-AC15-6681DD6A8B37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A0C7A-4796-45F4-AE93-39BF773199D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4064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>
            <a:extLst>
              <a:ext uri="{FF2B5EF4-FFF2-40B4-BE49-F238E27FC236}">
                <a16:creationId xmlns:a16="http://schemas.microsoft.com/office/drawing/2014/main" id="{D2F4EE06-12FF-D046-10CA-55362FCA3C16}"/>
              </a:ext>
            </a:extLst>
          </p:cNvPr>
          <p:cNvGrpSpPr/>
          <p:nvPr/>
        </p:nvGrpSpPr>
        <p:grpSpPr>
          <a:xfrm>
            <a:off x="1642221" y="251437"/>
            <a:ext cx="6007088" cy="5815255"/>
            <a:chOff x="455258" y="339361"/>
            <a:chExt cx="6165350" cy="6136374"/>
          </a:xfrm>
        </p:grpSpPr>
        <p:grpSp>
          <p:nvGrpSpPr>
            <p:cNvPr id="11" name="组合 10">
              <a:extLst>
                <a:ext uri="{FF2B5EF4-FFF2-40B4-BE49-F238E27FC236}">
                  <a16:creationId xmlns:a16="http://schemas.microsoft.com/office/drawing/2014/main" id="{88EB401C-4E8D-4AF8-3001-57A4A2073F98}"/>
                </a:ext>
              </a:extLst>
            </p:cNvPr>
            <p:cNvGrpSpPr/>
            <p:nvPr/>
          </p:nvGrpSpPr>
          <p:grpSpPr>
            <a:xfrm>
              <a:off x="3245566" y="382265"/>
              <a:ext cx="3138854" cy="3450123"/>
              <a:chOff x="3279530" y="339361"/>
              <a:chExt cx="3138854" cy="3450123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CE00325F-FC3C-C1C2-D7F1-666B5850357D}"/>
                  </a:ext>
                </a:extLst>
              </p:cNvPr>
              <p:cNvPicPr/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79530" y="382265"/>
                <a:ext cx="3138854" cy="3407219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822BE487-F85C-EA68-4092-ED348DB1E038}"/>
                  </a:ext>
                </a:extLst>
              </p:cNvPr>
              <p:cNvSpPr txBox="1"/>
              <p:nvPr/>
            </p:nvSpPr>
            <p:spPr>
              <a:xfrm>
                <a:off x="3390296" y="339361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5AF4ABB3-EBED-7D3A-0D0A-56BE44230599}"/>
                </a:ext>
              </a:extLst>
            </p:cNvPr>
            <p:cNvGrpSpPr/>
            <p:nvPr/>
          </p:nvGrpSpPr>
          <p:grpSpPr>
            <a:xfrm>
              <a:off x="455258" y="3929941"/>
              <a:ext cx="6165350" cy="2545794"/>
              <a:chOff x="455258" y="3929941"/>
              <a:chExt cx="6165350" cy="2545794"/>
            </a:xfrm>
          </p:grpSpPr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895B7C23-04CF-D260-D608-E00296C20D7D}"/>
                  </a:ext>
                </a:extLst>
              </p:cNvPr>
              <p:cNvPicPr/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5258" y="3929941"/>
                <a:ext cx="6165350" cy="2545794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E81B2E7F-7C21-4A3B-D4B8-6C7C9F75CBE7}"/>
                  </a:ext>
                </a:extLst>
              </p:cNvPr>
              <p:cNvSpPr txBox="1"/>
              <p:nvPr/>
            </p:nvSpPr>
            <p:spPr>
              <a:xfrm>
                <a:off x="592015" y="3929941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37325077-3EF1-0A96-68A6-891271E50669}"/>
                </a:ext>
              </a:extLst>
            </p:cNvPr>
            <p:cNvGrpSpPr/>
            <p:nvPr/>
          </p:nvGrpSpPr>
          <p:grpSpPr>
            <a:xfrm>
              <a:off x="657482" y="339361"/>
              <a:ext cx="2102100" cy="3350112"/>
              <a:chOff x="1010377" y="339361"/>
              <a:chExt cx="2102100" cy="3350112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26442BC9-3A10-20C8-5A4A-06FE8F00533D}"/>
                  </a:ext>
                </a:extLst>
              </p:cNvPr>
              <p:cNvPicPr/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10377" y="477861"/>
                <a:ext cx="2102100" cy="3211612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583091F9-D3EA-B4A3-FE65-40F0BBE85B8E}"/>
                  </a:ext>
                </a:extLst>
              </p:cNvPr>
              <p:cNvSpPr txBox="1"/>
              <p:nvPr/>
            </p:nvSpPr>
            <p:spPr>
              <a:xfrm>
                <a:off x="1078523" y="339361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5" name="TextBox 361">
            <a:extLst>
              <a:ext uri="{FF2B5EF4-FFF2-40B4-BE49-F238E27FC236}">
                <a16:creationId xmlns:a16="http://schemas.microsoft.com/office/drawing/2014/main" id="{2F73EB71-E5F5-AC91-D6FA-E0D9EC8B624C}"/>
              </a:ext>
            </a:extLst>
          </p:cNvPr>
          <p:cNvSpPr txBox="1"/>
          <p:nvPr/>
        </p:nvSpPr>
        <p:spPr>
          <a:xfrm>
            <a:off x="1596555" y="6066692"/>
            <a:ext cx="59508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914400"/>
            <a:r>
              <a:rPr lang="en-US" sz="1200" b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8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xpression heatmaps of the </a:t>
            </a:r>
            <a:r>
              <a:rPr lang="en-US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Rg1-3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 the 15 key enzyme genes for ginsenoside biosynthesis at different aged ginseng roots (A), in 14 tissues of a four-year-old plant (B), and in the four-year-old roots of different cultivars (C).</a:t>
            </a:r>
            <a:endParaRPr lang="en-US" sz="1200" i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66881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</TotalTime>
  <Words>48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P Zhang</dc:creator>
  <cp:lastModifiedBy>MDPI</cp:lastModifiedBy>
  <cp:revision>4</cp:revision>
  <dcterms:created xsi:type="dcterms:W3CDTF">2024-03-31T13:14:26Z</dcterms:created>
  <dcterms:modified xsi:type="dcterms:W3CDTF">2024-07-10T09:24:21Z</dcterms:modified>
</cp:coreProperties>
</file>